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14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orimoto Yoshiya" userId="2ce27d91c293e0dd" providerId="LiveId" clId="{D49C0556-FB0C-486E-A95A-8A9A7137E41E}"/>
    <pc:docChg chg="custSel addSld modSld modMainMaster">
      <pc:chgData name="Horimoto Yoshiya" userId="2ce27d91c293e0dd" providerId="LiveId" clId="{D49C0556-FB0C-486E-A95A-8A9A7137E41E}" dt="2022-06-22T08:21:26.165" v="56" actId="1076"/>
      <pc:docMkLst>
        <pc:docMk/>
      </pc:docMkLst>
      <pc:sldChg chg="addSp delSp modSp new mod">
        <pc:chgData name="Horimoto Yoshiya" userId="2ce27d91c293e0dd" providerId="LiveId" clId="{D49C0556-FB0C-486E-A95A-8A9A7137E41E}" dt="2022-06-22T08:21:26.165" v="56" actId="1076"/>
        <pc:sldMkLst>
          <pc:docMk/>
          <pc:sldMk cId="1097876416" sldId="256"/>
        </pc:sldMkLst>
        <pc:spChg chg="del">
          <ac:chgData name="Horimoto Yoshiya" userId="2ce27d91c293e0dd" providerId="LiveId" clId="{D49C0556-FB0C-486E-A95A-8A9A7137E41E}" dt="2022-06-22T08:14:25.414" v="2" actId="478"/>
          <ac:spMkLst>
            <pc:docMk/>
            <pc:sldMk cId="1097876416" sldId="256"/>
            <ac:spMk id="2" creationId="{576CDDBE-D361-CE5D-AE36-4237DBB9DDA2}"/>
          </ac:spMkLst>
        </pc:spChg>
        <pc:spChg chg="del">
          <ac:chgData name="Horimoto Yoshiya" userId="2ce27d91c293e0dd" providerId="LiveId" clId="{D49C0556-FB0C-486E-A95A-8A9A7137E41E}" dt="2022-06-22T08:14:25.414" v="2" actId="478"/>
          <ac:spMkLst>
            <pc:docMk/>
            <pc:sldMk cId="1097876416" sldId="256"/>
            <ac:spMk id="3" creationId="{A3B8F28A-784C-5951-B7AD-CCC4611331B9}"/>
          </ac:spMkLst>
        </pc:spChg>
        <pc:spChg chg="add mod">
          <ac:chgData name="Horimoto Yoshiya" userId="2ce27d91c293e0dd" providerId="LiveId" clId="{D49C0556-FB0C-486E-A95A-8A9A7137E41E}" dt="2022-06-22T08:21:26.165" v="56" actId="1076"/>
          <ac:spMkLst>
            <pc:docMk/>
            <pc:sldMk cId="1097876416" sldId="256"/>
            <ac:spMk id="6" creationId="{AF1BFE0F-DADF-F583-5387-9BE142C2C9F9}"/>
          </ac:spMkLst>
        </pc:spChg>
        <pc:spChg chg="add mod">
          <ac:chgData name="Horimoto Yoshiya" userId="2ce27d91c293e0dd" providerId="LiveId" clId="{D49C0556-FB0C-486E-A95A-8A9A7137E41E}" dt="2022-06-22T08:20:59.108" v="49" actId="1076"/>
          <ac:spMkLst>
            <pc:docMk/>
            <pc:sldMk cId="1097876416" sldId="256"/>
            <ac:spMk id="7" creationId="{10BFE036-C1D0-250D-C93F-B0A6FB962A2A}"/>
          </ac:spMkLst>
        </pc:spChg>
        <pc:spChg chg="add mod">
          <ac:chgData name="Horimoto Yoshiya" userId="2ce27d91c293e0dd" providerId="LiveId" clId="{D49C0556-FB0C-486E-A95A-8A9A7137E41E}" dt="2022-06-22T08:21:18.677" v="55" actId="1076"/>
          <ac:spMkLst>
            <pc:docMk/>
            <pc:sldMk cId="1097876416" sldId="256"/>
            <ac:spMk id="9" creationId="{31F1B525-7B47-C8C6-A40C-4987A50AB9FA}"/>
          </ac:spMkLst>
        </pc:spChg>
        <pc:picChg chg="add mod">
          <ac:chgData name="Horimoto Yoshiya" userId="2ce27d91c293e0dd" providerId="LiveId" clId="{D49C0556-FB0C-486E-A95A-8A9A7137E41E}" dt="2022-06-22T08:19:18.090" v="25"/>
          <ac:picMkLst>
            <pc:docMk/>
            <pc:sldMk cId="1097876416" sldId="256"/>
            <ac:picMk id="5" creationId="{01DBCC24-15CD-F7B4-4AE9-0AAA874E5B3C}"/>
          </ac:picMkLst>
        </pc:picChg>
      </pc:sldChg>
      <pc:sldMasterChg chg="modSp modSldLayout">
        <pc:chgData name="Horimoto Yoshiya" userId="2ce27d91c293e0dd" providerId="LiveId" clId="{D49C0556-FB0C-486E-A95A-8A9A7137E41E}" dt="2022-06-22T08:19:18.090" v="25"/>
        <pc:sldMasterMkLst>
          <pc:docMk/>
          <pc:sldMasterMk cId="1862942381" sldId="2147483648"/>
        </pc:sldMasterMkLst>
        <pc:spChg chg="mod">
          <ac:chgData name="Horimoto Yoshiya" userId="2ce27d91c293e0dd" providerId="LiveId" clId="{D49C0556-FB0C-486E-A95A-8A9A7137E41E}" dt="2022-06-22T08:19:18.090" v="25"/>
          <ac:spMkLst>
            <pc:docMk/>
            <pc:sldMasterMk cId="1862942381" sldId="2147483648"/>
            <ac:spMk id="2" creationId="{BF62AE3F-F0C9-B1E9-C771-8FD33063825D}"/>
          </ac:spMkLst>
        </pc:spChg>
        <pc:spChg chg="mod">
          <ac:chgData name="Horimoto Yoshiya" userId="2ce27d91c293e0dd" providerId="LiveId" clId="{D49C0556-FB0C-486E-A95A-8A9A7137E41E}" dt="2022-06-22T08:19:18.090" v="25"/>
          <ac:spMkLst>
            <pc:docMk/>
            <pc:sldMasterMk cId="1862942381" sldId="2147483648"/>
            <ac:spMk id="3" creationId="{449C72DE-5C09-B6AF-CE81-79ECF8275CE3}"/>
          </ac:spMkLst>
        </pc:spChg>
        <pc:spChg chg="mod">
          <ac:chgData name="Horimoto Yoshiya" userId="2ce27d91c293e0dd" providerId="LiveId" clId="{D49C0556-FB0C-486E-A95A-8A9A7137E41E}" dt="2022-06-22T08:19:18.090" v="25"/>
          <ac:spMkLst>
            <pc:docMk/>
            <pc:sldMasterMk cId="1862942381" sldId="2147483648"/>
            <ac:spMk id="4" creationId="{B011408B-E0C4-ADCC-71B8-9C7A09AC34A7}"/>
          </ac:spMkLst>
        </pc:spChg>
        <pc:spChg chg="mod">
          <ac:chgData name="Horimoto Yoshiya" userId="2ce27d91c293e0dd" providerId="LiveId" clId="{D49C0556-FB0C-486E-A95A-8A9A7137E41E}" dt="2022-06-22T08:19:18.090" v="25"/>
          <ac:spMkLst>
            <pc:docMk/>
            <pc:sldMasterMk cId="1862942381" sldId="2147483648"/>
            <ac:spMk id="5" creationId="{0EF8B939-FE52-5AFF-48F7-A3EC9043C745}"/>
          </ac:spMkLst>
        </pc:spChg>
        <pc:spChg chg="mod">
          <ac:chgData name="Horimoto Yoshiya" userId="2ce27d91c293e0dd" providerId="LiveId" clId="{D49C0556-FB0C-486E-A95A-8A9A7137E41E}" dt="2022-06-22T08:19:18.090" v="25"/>
          <ac:spMkLst>
            <pc:docMk/>
            <pc:sldMasterMk cId="1862942381" sldId="2147483648"/>
            <ac:spMk id="6" creationId="{57B4E80C-BC1C-26CD-F1E8-3F3BB1F9846B}"/>
          </ac:spMkLst>
        </pc:spChg>
        <pc:sldLayoutChg chg="modSp">
          <pc:chgData name="Horimoto Yoshiya" userId="2ce27d91c293e0dd" providerId="LiveId" clId="{D49C0556-FB0C-486E-A95A-8A9A7137E41E}" dt="2022-06-22T08:19:18.090" v="25"/>
          <pc:sldLayoutMkLst>
            <pc:docMk/>
            <pc:sldMasterMk cId="1862942381" sldId="2147483648"/>
            <pc:sldLayoutMk cId="646286356" sldId="2147483649"/>
          </pc:sldLayoutMkLst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646286356" sldId="2147483649"/>
              <ac:spMk id="2" creationId="{3E5FAA2B-5C37-3D42-66BF-F2C9103CFB50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646286356" sldId="2147483649"/>
              <ac:spMk id="3" creationId="{3E533D83-68B9-01F6-CEC2-783D02F4941C}"/>
            </ac:spMkLst>
          </pc:spChg>
        </pc:sldLayoutChg>
        <pc:sldLayoutChg chg="modSp">
          <pc:chgData name="Horimoto Yoshiya" userId="2ce27d91c293e0dd" providerId="LiveId" clId="{D49C0556-FB0C-486E-A95A-8A9A7137E41E}" dt="2022-06-22T08:19:18.090" v="25"/>
          <pc:sldLayoutMkLst>
            <pc:docMk/>
            <pc:sldMasterMk cId="1862942381" sldId="2147483648"/>
            <pc:sldLayoutMk cId="3433958849" sldId="2147483651"/>
          </pc:sldLayoutMkLst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433958849" sldId="2147483651"/>
              <ac:spMk id="2" creationId="{BB3E93FC-F974-7769-3539-13AC512339D4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433958849" sldId="2147483651"/>
              <ac:spMk id="3" creationId="{26688A65-B8A1-0775-3517-78CA07F8A69D}"/>
            </ac:spMkLst>
          </pc:spChg>
        </pc:sldLayoutChg>
        <pc:sldLayoutChg chg="modSp">
          <pc:chgData name="Horimoto Yoshiya" userId="2ce27d91c293e0dd" providerId="LiveId" clId="{D49C0556-FB0C-486E-A95A-8A9A7137E41E}" dt="2022-06-22T08:19:18.090" v="25"/>
          <pc:sldLayoutMkLst>
            <pc:docMk/>
            <pc:sldMasterMk cId="1862942381" sldId="2147483648"/>
            <pc:sldLayoutMk cId="1651291275" sldId="2147483652"/>
          </pc:sldLayoutMkLst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1651291275" sldId="2147483652"/>
              <ac:spMk id="3" creationId="{B3530555-E88C-B758-FFF5-07C628071ADB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1651291275" sldId="2147483652"/>
              <ac:spMk id="4" creationId="{AA4F0210-1480-5DCE-3E54-76CE713DDD18}"/>
            </ac:spMkLst>
          </pc:spChg>
        </pc:sldLayoutChg>
        <pc:sldLayoutChg chg="modSp">
          <pc:chgData name="Horimoto Yoshiya" userId="2ce27d91c293e0dd" providerId="LiveId" clId="{D49C0556-FB0C-486E-A95A-8A9A7137E41E}" dt="2022-06-22T08:19:18.090" v="25"/>
          <pc:sldLayoutMkLst>
            <pc:docMk/>
            <pc:sldMasterMk cId="1862942381" sldId="2147483648"/>
            <pc:sldLayoutMk cId="3190243393" sldId="2147483653"/>
          </pc:sldLayoutMkLst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190243393" sldId="2147483653"/>
              <ac:spMk id="2" creationId="{B377C690-8864-5CF2-3F10-FCBBD843D156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190243393" sldId="2147483653"/>
              <ac:spMk id="3" creationId="{829D46A1-0C56-C1EF-30CA-BBE8A5B892A7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190243393" sldId="2147483653"/>
              <ac:spMk id="4" creationId="{8DFA0C94-668C-8FA2-DD82-EAC75D7B1A80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190243393" sldId="2147483653"/>
              <ac:spMk id="5" creationId="{8F47F8FD-95F3-C07B-3C06-311C5237AF05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190243393" sldId="2147483653"/>
              <ac:spMk id="6" creationId="{BA1F1092-BB6B-2FFF-82E2-4F12B4D532BE}"/>
            </ac:spMkLst>
          </pc:spChg>
        </pc:sldLayoutChg>
        <pc:sldLayoutChg chg="modSp">
          <pc:chgData name="Horimoto Yoshiya" userId="2ce27d91c293e0dd" providerId="LiveId" clId="{D49C0556-FB0C-486E-A95A-8A9A7137E41E}" dt="2022-06-22T08:19:18.090" v="25"/>
          <pc:sldLayoutMkLst>
            <pc:docMk/>
            <pc:sldMasterMk cId="1862942381" sldId="2147483648"/>
            <pc:sldLayoutMk cId="3109340446" sldId="2147483656"/>
          </pc:sldLayoutMkLst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109340446" sldId="2147483656"/>
              <ac:spMk id="2" creationId="{614CE223-EF5D-D2CC-6746-2F99C12D9C7F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109340446" sldId="2147483656"/>
              <ac:spMk id="3" creationId="{0FB9924F-5AAA-B8F7-3AEC-FFD7FD4B39A9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109340446" sldId="2147483656"/>
              <ac:spMk id="4" creationId="{96B95A68-17C6-627E-9537-61A4F768A7EF}"/>
            </ac:spMkLst>
          </pc:spChg>
        </pc:sldLayoutChg>
        <pc:sldLayoutChg chg="modSp">
          <pc:chgData name="Horimoto Yoshiya" userId="2ce27d91c293e0dd" providerId="LiveId" clId="{D49C0556-FB0C-486E-A95A-8A9A7137E41E}" dt="2022-06-22T08:19:18.090" v="25"/>
          <pc:sldLayoutMkLst>
            <pc:docMk/>
            <pc:sldMasterMk cId="1862942381" sldId="2147483648"/>
            <pc:sldLayoutMk cId="380335380" sldId="2147483657"/>
          </pc:sldLayoutMkLst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80335380" sldId="2147483657"/>
              <ac:spMk id="2" creationId="{CAEAEEE3-7974-7B54-D57D-892F1E91E61F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80335380" sldId="2147483657"/>
              <ac:spMk id="3" creationId="{96785A86-43C3-E554-4366-BC992B5FFF02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380335380" sldId="2147483657"/>
              <ac:spMk id="4" creationId="{FB15EDD3-C643-9614-D77B-B972C284E2DB}"/>
            </ac:spMkLst>
          </pc:spChg>
        </pc:sldLayoutChg>
        <pc:sldLayoutChg chg="modSp">
          <pc:chgData name="Horimoto Yoshiya" userId="2ce27d91c293e0dd" providerId="LiveId" clId="{D49C0556-FB0C-486E-A95A-8A9A7137E41E}" dt="2022-06-22T08:19:18.090" v="25"/>
          <pc:sldLayoutMkLst>
            <pc:docMk/>
            <pc:sldMasterMk cId="1862942381" sldId="2147483648"/>
            <pc:sldLayoutMk cId="1583789354" sldId="2147483659"/>
          </pc:sldLayoutMkLst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1583789354" sldId="2147483659"/>
              <ac:spMk id="2" creationId="{64A72741-AB35-5362-C389-90C880DA8E61}"/>
            </ac:spMkLst>
          </pc:spChg>
          <pc:spChg chg="mod">
            <ac:chgData name="Horimoto Yoshiya" userId="2ce27d91c293e0dd" providerId="LiveId" clId="{D49C0556-FB0C-486E-A95A-8A9A7137E41E}" dt="2022-06-22T08:19:18.090" v="25"/>
            <ac:spMkLst>
              <pc:docMk/>
              <pc:sldMasterMk cId="1862942381" sldId="2147483648"/>
              <pc:sldLayoutMk cId="1583789354" sldId="2147483659"/>
              <ac:spMk id="3" creationId="{FB6D1C97-944F-F2D8-A4E0-48B3E650B382}"/>
            </ac:spMkLst>
          </pc:spChg>
        </pc:sldLayoutChg>
      </pc:sldMasterChg>
    </pc:docChg>
  </pc:docChgLst>
  <pc:docChgLst>
    <pc:chgData name="堀本 義哉" userId="2ce27d91c293e0dd" providerId="LiveId" clId="{9F48127B-B71B-463F-A792-A6F3F74FD280}"/>
    <pc:docChg chg="modSld">
      <pc:chgData name="堀本 義哉" userId="2ce27d91c293e0dd" providerId="LiveId" clId="{9F48127B-B71B-463F-A792-A6F3F74FD280}" dt="2022-06-30T07:54:18.755" v="1" actId="20577"/>
      <pc:docMkLst>
        <pc:docMk/>
      </pc:docMkLst>
      <pc:sldChg chg="modSp mod">
        <pc:chgData name="堀本 義哉" userId="2ce27d91c293e0dd" providerId="LiveId" clId="{9F48127B-B71B-463F-A792-A6F3F74FD280}" dt="2022-06-30T07:54:18.755" v="1" actId="20577"/>
        <pc:sldMkLst>
          <pc:docMk/>
          <pc:sldMk cId="1097876416" sldId="256"/>
        </pc:sldMkLst>
        <pc:spChg chg="mod">
          <ac:chgData name="堀本 義哉" userId="2ce27d91c293e0dd" providerId="LiveId" clId="{9F48127B-B71B-463F-A792-A6F3F74FD280}" dt="2022-06-30T07:54:18.755" v="1" actId="20577"/>
          <ac:spMkLst>
            <pc:docMk/>
            <pc:sldMk cId="1097876416" sldId="256"/>
            <ac:spMk id="6" creationId="{AF1BFE0F-DADF-F583-5387-9BE142C2C9F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41834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616603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931062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615863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829466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783992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202282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37357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765378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1161302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283735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F1BD67-8462-4095-ABBE-676130ADCE61}" type="datetimeFigureOut">
              <a:rPr kumimoji="1" lang="en-GB" smtClean="0"/>
              <a:t>30/06/2022</a:t>
            </a:fld>
            <a:endParaRPr kumimoji="1"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69918A-1FEB-4E13-B3BB-886CA99DDAC9}" type="slidenum">
              <a:rPr kumimoji="1" lang="en-GB" smtClean="0"/>
              <a:t>‹#›</a:t>
            </a:fld>
            <a:endParaRPr kumimoji="1" lang="en-GB"/>
          </a:p>
        </p:txBody>
      </p:sp>
    </p:spTree>
    <p:extLst>
      <p:ext uri="{BB962C8B-B14F-4D97-AF65-F5344CB8AC3E}">
        <p14:creationId xmlns:p14="http://schemas.microsoft.com/office/powerpoint/2010/main" val="716208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01DBCC24-15CD-F7B4-4AE9-0AAA874E5B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4871" y="886949"/>
            <a:ext cx="5222258" cy="508410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F1BFE0F-DADF-F583-5387-9BE142C2C9F9}"/>
              </a:ext>
            </a:extLst>
          </p:cNvPr>
          <p:cNvSpPr txBox="1"/>
          <p:nvPr/>
        </p:nvSpPr>
        <p:spPr>
          <a:xfrm>
            <a:off x="7045124" y="2724778"/>
            <a:ext cx="1261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 = 0.011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0BFE036-C1D0-250D-C93F-B0A6FB962A2A}"/>
              </a:ext>
            </a:extLst>
          </p:cNvPr>
          <p:cNvSpPr txBox="1"/>
          <p:nvPr/>
        </p:nvSpPr>
        <p:spPr>
          <a:xfrm>
            <a:off x="857491" y="407468"/>
            <a:ext cx="104770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5 Fig. Kaplan–Meier curves of recurrence-free-survival according to B3GALNT2 mRNA expression (n = 178).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1F1B525-7B47-C8C6-A40C-4987A50AB9FA}"/>
              </a:ext>
            </a:extLst>
          </p:cNvPr>
          <p:cNvSpPr txBox="1"/>
          <p:nvPr/>
        </p:nvSpPr>
        <p:spPr>
          <a:xfrm>
            <a:off x="1097183" y="6111979"/>
            <a:ext cx="999763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curve shown in red represents recurrence-free-survival of patients with B3GALNT2 mRNA-high tumors, the black curve that of those with low B3GALNT2 tumors.</a:t>
            </a:r>
          </a:p>
        </p:txBody>
      </p:sp>
    </p:spTree>
    <p:extLst>
      <p:ext uri="{BB962C8B-B14F-4D97-AF65-F5344CB8AC3E}">
        <p14:creationId xmlns:p14="http://schemas.microsoft.com/office/powerpoint/2010/main" val="1097876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47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orimoto Yoshiya</dc:creator>
  <cp:lastModifiedBy>堀本 義哉</cp:lastModifiedBy>
  <cp:revision>1</cp:revision>
  <dcterms:created xsi:type="dcterms:W3CDTF">2022-06-22T08:14:13Z</dcterms:created>
  <dcterms:modified xsi:type="dcterms:W3CDTF">2022-06-30T07:54:21Z</dcterms:modified>
</cp:coreProperties>
</file>